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35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14.xml" ContentType="application/vnd.openxmlformats-officedocument.presentationml.slide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36.xml" ContentType="application/vnd.openxmlformats-officedocument.presentationml.slide+xml"/>
  <Override PartName="/ppt/slides/slide7.xml" ContentType="application/vnd.openxmlformats-officedocument.presentationml.slide+xml"/>
  <Override PartName="/ppt/slides/slide5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9.xml" ContentType="application/vnd.openxmlformats-officedocument.presentationml.slide+xml"/>
  <Override PartName="/ppt/slides/slide48.xml" ContentType="application/vnd.openxmlformats-officedocument.presentationml.slide+xml"/>
  <Override PartName="/ppt/slides/slide47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8.xml" ContentType="application/vnd.openxmlformats-officedocument.presentationml.slide+xml"/>
  <Override PartName="/ppt/slides/slide57.xml" ContentType="application/vnd.openxmlformats-officedocument.presentationml.slide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6.xml" ContentType="application/vnd.openxmlformats-officedocument.presentationml.slide+xml"/>
  <Override PartName="/ppt/slides/slide46.xml" ContentType="application/vnd.openxmlformats-officedocument.presentationml.slide+xml"/>
  <Override PartName="/ppt/slides/slide4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3.xml" ContentType="application/vnd.openxmlformats-officedocument.presentationml.slide+xml"/>
  <Override PartName="/ppt/slides/slide45.xml" ContentType="application/vnd.openxmlformats-officedocument.presentationml.slide+xml"/>
  <Override PartName="/ppt/slides/slide42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84" r:id="rId6"/>
    <p:sldId id="285" r:id="rId7"/>
    <p:sldId id="288" r:id="rId8"/>
    <p:sldId id="289" r:id="rId9"/>
    <p:sldId id="290" r:id="rId10"/>
    <p:sldId id="291" r:id="rId11"/>
    <p:sldId id="280" r:id="rId12"/>
    <p:sldId id="282" r:id="rId13"/>
    <p:sldId id="283" r:id="rId14"/>
    <p:sldId id="293" r:id="rId15"/>
    <p:sldId id="294" r:id="rId16"/>
    <p:sldId id="295" r:id="rId17"/>
    <p:sldId id="296" r:id="rId18"/>
    <p:sldId id="297" r:id="rId19"/>
    <p:sldId id="298" r:id="rId20"/>
    <p:sldId id="299" r:id="rId21"/>
    <p:sldId id="300" r:id="rId22"/>
    <p:sldId id="276" r:id="rId23"/>
    <p:sldId id="301" r:id="rId24"/>
    <p:sldId id="302" r:id="rId25"/>
    <p:sldId id="303" r:id="rId26"/>
    <p:sldId id="304" r:id="rId27"/>
    <p:sldId id="305" r:id="rId28"/>
    <p:sldId id="306" r:id="rId29"/>
    <p:sldId id="307" r:id="rId30"/>
    <p:sldId id="277" r:id="rId31"/>
    <p:sldId id="308" r:id="rId32"/>
    <p:sldId id="309" r:id="rId33"/>
    <p:sldId id="311" r:id="rId34"/>
    <p:sldId id="312" r:id="rId35"/>
    <p:sldId id="279" r:id="rId36"/>
    <p:sldId id="321" r:id="rId37"/>
    <p:sldId id="322" r:id="rId38"/>
    <p:sldId id="323" r:id="rId39"/>
    <p:sldId id="324" r:id="rId40"/>
    <p:sldId id="272" r:id="rId41"/>
    <p:sldId id="273" r:id="rId42"/>
    <p:sldId id="325" r:id="rId43"/>
    <p:sldId id="326" r:id="rId44"/>
    <p:sldId id="314" r:id="rId45"/>
    <p:sldId id="315" r:id="rId46"/>
    <p:sldId id="274" r:id="rId47"/>
    <p:sldId id="313" r:id="rId48"/>
    <p:sldId id="275" r:id="rId49"/>
    <p:sldId id="268" r:id="rId50"/>
    <p:sldId id="269" r:id="rId51"/>
    <p:sldId id="316" r:id="rId52"/>
    <p:sldId id="270" r:id="rId53"/>
    <p:sldId id="271" r:id="rId54"/>
    <p:sldId id="317" r:id="rId55"/>
    <p:sldId id="318" r:id="rId56"/>
    <p:sldId id="327" r:id="rId57"/>
    <p:sldId id="319" r:id="rId58"/>
    <p:sldId id="320" r:id="rId5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72" y="4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294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659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395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914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862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6603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0160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7441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3674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638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503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3148B1-1760-4786-B2B1-69929CEDF248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B27A9-34D6-419A-A711-069E387461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96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7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0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5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8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5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8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1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jpe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6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png"/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6.pn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2.png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pn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5.pn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8.png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1.png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png"/><Relationship Id="rId2" Type="http://schemas.openxmlformats.org/officeDocument/2006/relationships/image" Target="../media/image11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4.png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png"/><Relationship Id="rId2" Type="http://schemas.openxmlformats.org/officeDocument/2006/relationships/image" Target="../media/image1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7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png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3.png"/><Relationship Id="rId2" Type="http://schemas.openxmlformats.org/officeDocument/2006/relationships/image" Target="../media/image122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png"/><Relationship Id="rId2" Type="http://schemas.openxmlformats.org/officeDocument/2006/relationships/image" Target="../media/image124.pn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png"/><Relationship Id="rId2" Type="http://schemas.openxmlformats.org/officeDocument/2006/relationships/image" Target="../media/image126.png"/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9.png"/><Relationship Id="rId2" Type="http://schemas.openxmlformats.org/officeDocument/2006/relationships/image" Target="../media/image12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0.png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2.png"/><Relationship Id="rId2" Type="http://schemas.openxmlformats.org/officeDocument/2006/relationships/image" Target="../media/image13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3.png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5.png"/><Relationship Id="rId2" Type="http://schemas.openxmlformats.org/officeDocument/2006/relationships/image" Target="../media/image13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6.png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8.png"/><Relationship Id="rId2" Type="http://schemas.openxmlformats.org/officeDocument/2006/relationships/image" Target="../media/image137.png"/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0.png"/><Relationship Id="rId2" Type="http://schemas.openxmlformats.org/officeDocument/2006/relationships/image" Target="../media/image139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1.png"/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56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107504" y="476672"/>
            <a:ext cx="5112568" cy="594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43	666144	666164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0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43:666144-66616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ACGGCGTGACAGTCGGCATAATATGTATGTCGTCCGTGCCGCGTGCTCACTTCTCTTTCTG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18	666529	666547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9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0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0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118:666529-66654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ACGGCCGGGCGGAACGGCACCGCGGATGTGCCGTCGCGGCCGCGTGCTCACTGCTCTGTCTG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48	650575	650593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9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	2	20	 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48:650575-65059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ACAGAAGAGAGTGAGCATATATAGTGCTTTTCTTGCATATGTGCATATATGCAGGCTGCATATAGATCTAGATCGAGTTCATGCATGTGCCTGAAGCTATATGTGCTCACTTCTCTTCCTG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4128" y="0"/>
            <a:ext cx="8572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11119" y="158003"/>
            <a:ext cx="65722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28384" y="169607"/>
            <a:ext cx="9906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531161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2376" y="466725"/>
            <a:ext cx="1524000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23528" y="621843"/>
            <a:ext cx="6870848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702	419965	419985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702:419965-41998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CACATGTAGCCCAATCCATGTTGTGGTTGCCTGCTGTGGGTGGCGTGCAAGGAGCCAAGCA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60	274958	274978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	1	2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260:274958-27497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CTCGCGTAGCTGCCAACTCAGTTGAGCTCCGATCGAGGGCACGTACGTTGGCTCTACTGCGGATGGCGTGCGAGGAGCCAAGCATG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91214" y="471488"/>
            <a:ext cx="857250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661556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1637" y="457200"/>
            <a:ext cx="242887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952" y="452438"/>
            <a:ext cx="126682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2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107504" y="548680"/>
            <a:ext cx="4464496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89	874188	874207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ATAAACCTCTGCATC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5..134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ATAAACCTCTGCATC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5..135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89:874188-87420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CTGGGCGCAGTGGTTTATCGATCCCTTCCCTGCCTTGTGCTGATCCGGGGTGGTGATTTCTCGAGAGGTTTTTCTGCTTGTTACATACAGCTTACAACAACGCGGGAATCGATCGATAAACCTCTGCATCCGG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55	671024	671043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ATAAACCTCTGCATC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1	13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ATAAACCTCTGCATC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1	13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55:671024-671043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GGGCGCAGTGGTTTATCGATCCCTTCCCTGCCTTGTCCTGATCCGGGGTGGTGATTTCTGGAGAGGTTTTTCTTGTTACATACAGCTTACAACAACGCGGGAATCGATCGATAAACCTCTGCATCCGG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92	49634	49654	+	</a:t>
            </a:r>
          </a:p>
          <a:p>
            <a:r>
              <a:rPr lang="en-GB" sz="1000" dirty="0"/>
              <a:t>TCGATAAACCTCTGCATCCAG 	135	155	</a:t>
            </a:r>
            <a:endParaRPr lang="en-GB" sz="1000" dirty="0" smtClean="0"/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92:49634-49654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GGCGCAGCGGTTTATCGATCTCTTCCCTGCCTTGTGCTGATCCCCGGCGCCAACTTTTTGGTGGTTTCTTGAGAGATTTTCTTGTGAAAAGGAGGCAAGCTATCTTCTTGTTACAGCAACGCAGGAATCGATCGATAAACCTCTGCATCCAG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9396" y="442913"/>
            <a:ext cx="1866900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55529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4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5496" y="488861"/>
            <a:ext cx="5256584" cy="48628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06	20534	20554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2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06:20534-2055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GAGAAGCAGGGTACGTGCATTCTTTCCCCGCCGATTTGGCATTCCCGACCGGCCGGCTCGCCCCGCCGCCGGCTCCAGCGCCGATGCATGCATGTACCCTTCTTCTCCACCGTG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68	 214841 	214861	-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2	22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68:214841-21486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GAAGCAGGGCACGTGCAAAGATCGGCGCACGCACGTGAGCGCATGCATGGATCGTTGTGCACGCGCTCCCCTTCTCCAC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364	717875	717895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364:717875-71789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GAAGCAGGGCACGTGCAATCATATCGATCTTCTCTTCCTACCTTGTGGATTAGAACTAGTACTGCACGTGCTCTCCTCCTC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404664"/>
            <a:ext cx="1504950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2200" y="457298"/>
            <a:ext cx="89535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0679" y="332656"/>
            <a:ext cx="164782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141938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4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323528" y="692696"/>
            <a:ext cx="4968552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433	356066	356086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2	22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433:356066-35608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GAGAAGCAGGGCACGTGCATTGCTAAGCTAAACCACTAATGTTAAGCTAAATATACTCTAGTTTAGCTACATGTTCATGTGCCCGTCTTCTCCACC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037	154568	154588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037:154568-15458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GAGAAGCAGGGTACGTGCATTCTTTCCTCGCCGATTTGGCATTCCCGGCCTGCTCGCGCCGCCGCGCGCGACCTGGGTGCCACCGGCCGTCTGCAGCGCCGATGCATGCATGTGCCCTTCTTCTC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214	125347	125367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2	22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2214:125347-12536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GAAGCAGGGCACGTGCAAAGACCGGAGCACGCACGTGAGTGCATGCGTGGATCGTTGTGCACGCGCTCCCCTTCTCC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136307"/>
            <a:ext cx="936104" cy="48693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4247" y="1052736"/>
            <a:ext cx="2304257" cy="5379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98754" y="475828"/>
            <a:ext cx="637742" cy="4393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540198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4288" y="-27384"/>
            <a:ext cx="1957081" cy="53819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064" y="1239341"/>
            <a:ext cx="2196412" cy="54300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4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107504" y="908720"/>
            <a:ext cx="5040560" cy="5170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214	125347	125367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2	22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214:125347-12536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GAAGCAGGGCACGTGCAAAGACCGGAGCACGCACGTGAGTGCATGCGTGGATCGTTGTGCACGCGCTCCCCTTCTCCACC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06	10772	10792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06:10772-1079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TTCTTTCCCTGCCGATTTGGCATTCCCGACCGGCCGGCTCGCCCCGCCGCCGGCTCCAGCGCCGATGCATGCATGTGCCCTTCTTCTCCACCGTG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06	11386	11406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06:11386-1140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TACGTGCATTCTTTCCCTGCCGATTTGGCATTCCCGACCGGCCGGCTCGCCCCGCCGCCGGTTCCAGCGCCGATGCATGCATGTGCCCTTCTTCTCC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3448" y="476672"/>
            <a:ext cx="670720" cy="39604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508410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1555" y="457200"/>
            <a:ext cx="199072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5497" y="1205458"/>
            <a:ext cx="5832648" cy="40626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92	256377	256397	+	</a:t>
            </a: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AA 	1	21	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	</a:t>
            </a:r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92:256377-256397</a:t>
            </a: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AACGCCCATCTGATCTAACGTCGCTGCGTGGCAGTGGCATGTGCTGCTAATGTCCAGCTTTGGATAGGTCGTTCGTGTGCCCGTTTTCTCCA</a:t>
            </a: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445	125699	125719	+	</a:t>
            </a: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1	21</a:t>
            </a:r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445:125699-125719</a:t>
            </a: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TTACCATCCAATGGCGTCGCCATGCTCCTTCTCTGAGGAGCTAGCTCATACCTGCATGGATGGTTCTTCATGTGCCCGTCTTCTCCA</a:t>
            </a: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638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61963"/>
            <a:ext cx="177165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7614423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3681" y="716235"/>
            <a:ext cx="155257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1" y="620688"/>
            <a:ext cx="5144169" cy="544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587	52167	52187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AA 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587:52167-5218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AACGCCAATCTGATCTAACTTCGTTGCGTGGCAGTGGCGTGTGTTGCATGCTATTGTTCAGCTTTGGATAGCCGTTCATGTGCCCGTCTTCTC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569	40820	40840	+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1	21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569:40820-4084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TGCATATCGGTCATCTCCTCCTACCTTGTGTAGAACTAGCTAGTGGTGCACGTGTTCTCCTTCTCCA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835	95901	95921	+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 	1	21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835:95901-95921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AAGCAGGGCACGTGCATTACCATCCAATGGCGCCATACCTGGATGGATGGTTCTTCATGTGCCCGTCTTCTCCA</a:t>
            </a:r>
          </a:p>
        </p:txBody>
      </p:sp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6867" y="-27384"/>
            <a:ext cx="153352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41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7429" y="447675"/>
            <a:ext cx="981075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921152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6927" y="115049"/>
            <a:ext cx="73342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44624"/>
            <a:ext cx="1219200" cy="5895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2" y="930200"/>
            <a:ext cx="5832648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PH01000017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7724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77260	-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 GGAATGTTGTCTGGTTCAA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17:1177240-117726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TGTTGTCTGGTTCAAGGCCTCTTGGGGATGTGATTTATTAGGATGCATCTCTCGGATCTTTGAGATCTCGGACCAGGCTTCGTTCCC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76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7727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77295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122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4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TCGGACCAGGCTTCATTCCCC          124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44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76:377275-37729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GGAATGTTGTCTGGCTCGGGGTTCTCTCTCTCTATGTCTCTCTTCCTCCTCAATCTCTCCCTCATTTTTAGAGAGATCAAGAAGAGTGAGAGAGAGATGAGAGTAGATGGGTATAGATCTCGGACCAGGCTTCATTCCC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9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	769319	769339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65	85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99:769319-769339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GGGGAGTGTTGTCTGGTCCGAGACCTAACACGACGGCCGGCCGCGGCACGGTGGGCGGTTTCGGACCAGGCTTCATTCCCC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83082" y="260648"/>
            <a:ext cx="136207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3517007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5010" y="1571191"/>
            <a:ext cx="2605502" cy="53141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7505" y="1606148"/>
            <a:ext cx="5817618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54	85078	85098	-	</a:t>
            </a:r>
          </a:p>
          <a:p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78	98	</a:t>
            </a:r>
            <a:endParaRPr lang="en-GB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554:85078-85098</a:t>
            </a: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GGGAATGATGTCGGGTCTGAAGACGTGCGCTCGGTGGGACACGGCCGGGACTAGAGCCCTCCGTGCGTGTGGTTTCGGACCAGGCTTCATTCCCC</a:t>
            </a: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958	454632	454652	-	</a:t>
            </a:r>
          </a:p>
          <a:p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96	116	</a:t>
            </a:r>
            <a:endParaRPr lang="en-GB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958:454632-454652</a:t>
            </a:r>
          </a:p>
          <a:p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CTGGAATGGAGGTTGATCCAAGATCCTCGGTCCACAATGTTAGGGCCTTGTAGTAAGGACCGTTTTGTTTTCCGTGTTTTTGTTATCGAGGATCTCGGACCAGGCTTCATTCC</a:t>
            </a:r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-27384"/>
            <a:ext cx="867687" cy="55549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9424858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5" y="992917"/>
            <a:ext cx="612068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411	351471	351491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 GGAATGTTGTCTGGTTCAA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8	28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93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      95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5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411:351471-35149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GAGTGGAATGTTGTCTGGTTCAAGGCTTTGCTTGTGATGATTTGAGGATGATTAATTGCACAATTTTTTCATTCCTCTAATCTGCGGGGTCTCGGACCAGGCTTCATTCCC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5158	36955	36975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8	98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5158:36955-36975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GGAATGAAGTCCGGTCTGAAGACGTGCGCGCCGTGGGGCACGGCCGGGACTAGAGCCATCCGTGCGTGTGGTTTCGGACCAGGCTTCATTCCCC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2" y="260648"/>
            <a:ext cx="162877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28967" y="279698"/>
            <a:ext cx="1009650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52034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0872747">
            <a:off x="5467323" y="702544"/>
            <a:ext cx="140970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5496" y="473759"/>
            <a:ext cx="5961634" cy="6093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3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5240	55259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G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534:55240-55259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ACAGAAGAGAGTGGGCACACAGCGGCCAGACTGCATCTAAACACGGCTGCTGCCGGTGACAAAGACGACGGATGGAAAGACAGACGCAGCTGCTGTTGCGTGCTCACTTCTCTCTCTGTCAGCT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569	290526	290544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569:290526-29054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ACGGCCGGCGGAACGGCACCGGCGGGGGGGGTGCCGTCGCGGCCGCGTGCTCACGGCTCTTTCTGTCA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793	mir156g 	149114	149132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	2	20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793:149114-14913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ATGGTGTGACCGACATAATATCTGTGCCGTTCTTGTTGCGTGCTCACTCTTTTTTTGTCAG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00392" y="907876"/>
            <a:ext cx="1028700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5150" y="15205"/>
            <a:ext cx="85725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5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1138576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9512" y="548680"/>
            <a:ext cx="6120680" cy="594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PH01000103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3110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31125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62	8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64	84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103:331105-33112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ATGTTGTCTGGCCCGAGACCGGACAGTGGCGGATGTCTCCGCGGCACAGATGGACGGTCTCGGACCAGGCTTCATTCCCC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312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6911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69139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4	94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312:369119-369139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GGAACGTTGTCTGGTCCGAGACCTAACACGGCGGCCGGATCGATCGATGCCGCGGTACGGTGGGCGGTTTCGGACCAGGCTTCATTCCCCC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327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8170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81720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4	13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6	136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327:581700-58172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ATGTTGTCTGGCTCGGGGCTCTCTCTTTCTCTCTCCCTTCCTCCTCAATCTCTCTCTCTATTAAAGATCAAGAAAGAGTGCGGGGGGGATGAGAGTAGATGGTTGTAGATCTCGGACCAGGCTTCATTCCC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0152" y="481013"/>
            <a:ext cx="1133475" cy="5895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3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7985" y="457200"/>
            <a:ext cx="71437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3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7914" y="452438"/>
            <a:ext cx="590550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2801122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1393304"/>
            <a:ext cx="2683978" cy="54200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964" y="606747"/>
            <a:ext cx="5363124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565	46553	46573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CTCGGACTAGGCTTCATTCC 	95	115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565:46553-4657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CTGGAATGGAGGCTGATCCAAGATCCTCGTCCAAAATGTTAGGACATTGTAGTAAGGGCCATTTTATTTTTTGGTGTTTCATTACCGAGGATCTCGGACTAGGCTTCATTCC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030	164182	164202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GGAATGTTGTCTGGTTCAA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..21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	84..10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6..106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030:164182-16420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TGTTGTCTGGTTCAAGGTCCTGCTTGTCATTTGAGGATGATTTATTACATGATTTTTTCATTTTCTCTAATCTACGGGATCTCGGACCAGGCTTCATTCCCC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256		119654	119674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GGAATGTTGTCTGGCTCGAG 	4..23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GGAATGTTGTCTGGCTCGAGG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..24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GGACCAGGCTTCATT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58..78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GACCAGGCTTCATTCC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60..80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256:119654-119674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GGAATGTTGTCTGGCTCGAGGTGAAGAAACCTTAAGTTTTGATCAACAGATTGATCTCGGACCAGGCTTCATTCCCC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6</a:t>
            </a:r>
            <a:endParaRPr lang="en-GB" dirty="0"/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7978" y="44624"/>
            <a:ext cx="844342" cy="5251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2320" y="-27384"/>
            <a:ext cx="1688684" cy="5285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7948960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35496" y="548680"/>
            <a:ext cx="6120680" cy="5786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72	604147	604168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3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72:604147-60416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AAGCTGCCAGCATGATCTGATCTTTCTTTCATTTTTGCTTTGGCTGATTTCGTTCTTGAAAAAACTGGATGCCAAATAAGATTCAGATCGTGCTGCGCGGTTTCACCTG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95	509737	509758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	2	23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95:509737-50975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AGCTGCCAGCATGATCTGGTGTTCGAACATGGACCGAATCTATGCGTTGTTAGGGCAATTATCATTGTTCTTGTAAGGTTCTCAAGATTTTGGTGTGTCGAAGTGCGAAGGAAGTTGATGGCTCTTT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05	1016603	1016622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3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105:1016603-101662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AGCTGCCAGCATGATCTAGCTTTGATTGACAGTAGTTTTGCCATACAGTCGTCGGATCACATGTGTGTTTCTGCATGTCAATCATTGTTAGATCATGTATGACAGCCTCA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8710" y="188640"/>
            <a:ext cx="74295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1091" y="179115"/>
            <a:ext cx="58102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1171" y="332656"/>
            <a:ext cx="69532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555290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http://srna-tools.cmp.uea.ac.uk/plant/jobs/MyJob_3BZBHlVUu/results/Structure_plot_bitmap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2080" y="44624"/>
            <a:ext cx="3789039" cy="37890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7504" y="908720"/>
            <a:ext cx="5616624" cy="4862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23	803290	803308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	2	23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123:803290-80330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AGCTGCCAGCATGATCTGATCGTCGAGCATGGACCGAATCTATGAGTCGGTAGTGCAATTATCATTGTTCTTGTAAGGTTTTCAAGATTTTTGTCGTGTCGAAGTGTGAAGGAAGGTGTTGGCTCTTGATGAGTGTTGATACTAGAGGGGTGTGTGGGTTTAGTGGTAGAAGTAGAACTTCCATTGCTCTTGTAAGGCTTAGGGATACTAGATCATGTTGCAGGAGGTGTAGGTTTGGTTAGAGCAATTATCATGCATGGAATTTGGCTCCATCAGATCATGTTGCAGCTTCACTC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08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36373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36391	-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	2	23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08:536373-53639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AGCTGCCAGCATGATCTGAAAGCATATGTTCTTGATGATCATTTGTAAATTGATTGCTCAGGAAATAAGAAATCAGATCATCTGGCAGTTTCAT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05800" y="861864"/>
            <a:ext cx="8382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5306102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7" name="Picture 5" descr="http://srna-tools.cmp.uea.ac.uk/plant/jobs/MyJob_BZi3sDA5P/results/Structure_plot_bitmap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8" y="3894533"/>
            <a:ext cx="2990850" cy="29908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176" y="15148"/>
            <a:ext cx="1838325" cy="584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7505" y="644490"/>
            <a:ext cx="5112568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46	455019	455037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	2	23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546:455019-45503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AAGCTGCCAGCATGATCTGACAATAGTACTGAAGATTTCGAACCTAGCTAGATGGGAATTAAGCCATCAGATCATCTGGCAGTTTCAT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775	271258	271276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	2	23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775:271258-27127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AAGCTGCCAGCATGATCTGATATTTCTTCCATTTTTGCTAGCTTTGACTGATTTAGTTCTTGCAAAAATTGGATGCCTAAGATTCAGATCGTGCTGCGCAGTTTCACC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006	362572	362590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	2	23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006:362572-362590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AGCTGCCAGCATGATCTGGTTGATGAGCACCACTCCAACTTAGAGTTATGACATCCTCTGATCCAAAATTTCCATGGAGTGGCAATTGGCAAGCCTCATGTCGTGGGTGCTTCAGGAGGTATATATGACTTTGATTTGTGGAAGAAGCCTTTAAGGTTGTCTAATGGAGGCTTCCAATTGGTTCCATCAGATCATGTTGCAGCTTC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88746" y="280788"/>
            <a:ext cx="1047750" cy="584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3742877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5" y="723468"/>
            <a:ext cx="5112568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88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42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443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884:5425-544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AGCTGCCAGCATGATCTAGCTCTGAGTGATCACCAGGAGAAGATATGTATATATGGAGGCTGTCATATCTTGGGGGTCATCCCTTGCTAGGTCATGCTGCGGCAGCCTCACTT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236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60032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60050	-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3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236:160032-160050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AAGCTGCCAGCATGATCTGGTTGATGAACACCAGTCCAACTTAGAGTTGTGAGATCCTGATCCAAAACTTCCATGGAGTGGCAAGCTTCATGATGTGGGTGCTTGCAGAGGTATATATGAGTTTGATTTGTGGAAGCCTTTGAGGTTGTCCAGTGGAGGCTTCCAATTGGTTCCATCAGATCATGTTGCAGCTTCATT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0072" y="116632"/>
            <a:ext cx="107632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3906" y="332656"/>
            <a:ext cx="292417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937522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3529" y="1207780"/>
            <a:ext cx="6048672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162033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1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37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3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162033:519-53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AGCTGCCAGCATGATCTGATGAGCCTACTTGAGTGCATAATTGATTATCAAAACTAATCGTCAGATCATGCTGTGCAGTTTCA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26510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62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80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3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265105:262-280 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AGCTGCCAGCATGATCTGATGAGCCTACTTGAGTGCATAATTGATTATCAAAACTAATCGTCAGATCATGCTGTGCAGTTTC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he last 2 are the same – but they belong to different </a:t>
            </a:r>
            <a:r>
              <a:rPr lang="en-GB" sz="10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contigs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1146" y="282609"/>
            <a:ext cx="1028700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24328" y="465732"/>
            <a:ext cx="1066800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5067689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1202" y="1628800"/>
            <a:ext cx="3607302" cy="5040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2" y="1751325"/>
            <a:ext cx="5184576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2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380033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80054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25:1380033-138005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AGCTTTGATTGAGTACTATTGGTATACAGTCGTAGGATCACATGTATGTTTTCTATCTGCATGTGAATCATTATTAGATCATACCTGACAGCCTC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7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7198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72003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174:371984-37200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AGCTCTGAGTGATCAACATGAAGCGCACATACATGTTTGTGTGTGGATTTAAGCTGATATTGTGGTCATGCCTTGCTAGGTCATGCTGCGGCAGCCTCA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150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823714" y="1945039"/>
            <a:ext cx="4824536" cy="116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0849680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9982" y="2266925"/>
            <a:ext cx="3028522" cy="4474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7504" y="1053891"/>
            <a:ext cx="6192688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94	665524	665545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194:665524-66554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AAGTAGAGCGCTTATACATAGATGATTTGCAACGTAGAGGCAGAGCTAGCTAGATGGGTAAGCCATCAGATCATCTGGCAGTTTCATCCTCT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758	231606	231625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758:231606-231625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AACTTCTGGGGGGAGTAGGCAATGCCATTGTGAATGTATTTGTCTTGTTCATGGAAAAATCAGCCTGCTGGTTTTCAATGGGCATTCAAGATATATGCATGCATGGCAGTGTGATGTATGAGGCTTCTAAGTAATGGTTAGATCATGCTGTGACAGTTTCA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1309528">
            <a:off x="6558587" y="178481"/>
            <a:ext cx="893349" cy="51662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539166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6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382952">
            <a:off x="7633683" y="188700"/>
            <a:ext cx="1266825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79512" y="614293"/>
            <a:ext cx="5832648" cy="5170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913	252366	252385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913:252366-25238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AGCTCTGAGTGATCAACAAGAAGCACACATACATGTTTGTGTGTGGATTTGAGCTCTTGTGGTCATGCCTTGCTAGGTCATGCTGCGGCAGCCTCA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764	1280	1301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2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764:1280-130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GACGAGTGCCTAGTTGAGTGGGAATTGATGATTAAAAGTAATTATCAGATCATGCTGTGCAGTT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850	88535	88554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850:88535-88554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AGCTGCCAGCATGATCTAGCTTCTTGGGGGAGTAGGCAATGCCATTCTGCATCTGCTGTCTGTGTCTGGCTCATGAGAACTCAGCTTGCTGGTTTTCAATGGGCATTCATGATATGTGCATGGCAGTGTGATGTATGAGGCTTCTAAGTAATGGTCAGATCATGCTGTGACAGTTTCA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355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4778" y="2852936"/>
            <a:ext cx="1743606" cy="3816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7</a:t>
            </a:r>
            <a:endParaRPr lang="en-GB" dirty="0"/>
          </a:p>
        </p:txBody>
      </p:sp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44624"/>
            <a:ext cx="8191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09117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6136" y="471488"/>
            <a:ext cx="1600200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8104" y="116632"/>
            <a:ext cx="79057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107504" y="548680"/>
            <a:ext cx="5040560" cy="62478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501	58956	58973	-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	2	20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501:58956-58973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ACGGCTGGGCAGAACGGCACCGGCGGGGATGTGCCGTCGCGGTCGCGTGCTCACCGCTCTTTCTGTCA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86	12181	12199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	2	20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86:12181-12199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CACGACGTGACTGGCATCACAGGTATGCCGTTCTCATCGCGTGCTCGCTCCTCTTTCTGTCAGCCT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780	82474	82492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GACAGAAGAGAGTGAGCAC 	3	21	 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780:82474-82492 TGACAGAAGAGAGTGAGCACACGACCGGGCGGAACGGCACCGGTGGATGTGCCGTCGCGGCCGCGTGCTCACTGCTCTGTCTGTCA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6615" y="461963"/>
            <a:ext cx="88582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5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1138576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980728"/>
            <a:ext cx="6840760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85	406038	406055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	23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CCGCCTTGCACCAAGTG 	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50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67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 CCCGCCTTGCACCAAGTGA 	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0	68		0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 CCCGCCTTGCACCAAGTGAA 	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0	69		0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 GATCCCGCCTTGCACCAAGTGAA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47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0		0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 CCCGCCTTGCACCAAGTGAAT 	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0	70		0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85:406038-406055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CGCTTGGTGCAGATCGGGACCCGCCACCCGCGCCGTCGGACCGGATCCCGCCTTGCACCAAGTGAAT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80	263252	263271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CCGCCTTGCACCAAGTG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48	65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CCGCCTTGCACCAAG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48	66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80:263252-263271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CTTGGTGCAGATCGGGACCCGCCACCCGCGCCGCCGGGCCGGATCCCGCCTTGCACCAAGTG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2" y="213994"/>
            <a:ext cx="96202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7173" y="332656"/>
            <a:ext cx="105727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2757822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2280" y="-35497"/>
            <a:ext cx="1152525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7504" y="1120676"/>
            <a:ext cx="6336704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8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73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754	-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3	9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3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4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3	94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89:15734-1575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CCAAGGATGACTTGCCGCCGACCGGCAGTGTCGCCGCCGGCAGTCTGTGACATGCTGCATGGTTGCCCGGCAAGTCTGTCCTTGGCTACA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8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591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65934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3	9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3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4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3	94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89:65914-6593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CCAAGGATGACTTGCCGCCGACCGGCAGTGTCGCCACCGGCAGTCCGTGGCATGCTGCATGGTTGCCCGGCAAGTCTGTCCTTGGCTACA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24850" y="260648"/>
            <a:ext cx="819150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1187497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1381425"/>
            <a:ext cx="5832648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89	120783	120803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4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4	9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5	9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4	95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89:120783-12080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CCAAGGATGACTTGCCGCCCGGCCGGCAGTGTCGCCGCCGGCAGTCTGTGACATGCTGCATAGTTGCTCGGCAAGTCTGTCCTTGGCTACA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917	109243	109263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917:109243-10926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GCCAAGGATGACTTGCCGGGGTGCCGCCGGCGCCGGCCGCCCGGCAGGCATCGATTTCAAAGGGAAAGCCTCTGTTTTTGAGAGACTGTTGGTGTTGTCGCCGGCAAGTTTGTCCATGGC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2886" y="59524"/>
            <a:ext cx="1689918" cy="42621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3022" y="2964532"/>
            <a:ext cx="2002532" cy="3893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7696175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483" y="967441"/>
            <a:ext cx="6768752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2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2083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20851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24:320830-32085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AGGATGACTTGCCGGCTCCTGGTGCTGGGGAAATCTCAGCTTTGTTGAGCCTCAGATAGTTAGCCGGCAGGTCTGTCCTTGGC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45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74608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474628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450:474608-474628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AGGATGACTTGCCGGGTATGTGCATGCATGTTTCAAGAGAGCATATGCAATGCATCCCTGTTTTGAATCCATGCTAATATTTTCCGGCAAGTTGTCCTTGGCTACAT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4248" y="188640"/>
            <a:ext cx="104775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8339" y="447675"/>
            <a:ext cx="1000125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5551536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6216" y="116632"/>
            <a:ext cx="1181100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7504" y="825093"/>
            <a:ext cx="5976664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459	60524	60545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73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73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AAGTCTGTCCTTGGCT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74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CAAGTCTGTCCTTGGCTA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73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4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3459:60524-6054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AGGATGACTTGCCGCCCGGCCGGCAGTGTCGCCGCCGGCAGTCTGTGACATGCTGCATGGTTGCCCGGCAAGTCTGTCCTTGGCTACA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804	20354	20374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CCAAGGATGACTTGCC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3804:20354-20374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CCAAGGATGACTTGCCGGCTCCTGGTGTTGGGGAAATCTCAAGTTTATTGAGCCTTAGAAAGTTAGCCGGCAAGTCTGTCCTCGGC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66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50063" y="457200"/>
            <a:ext cx="111442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2560613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188640"/>
            <a:ext cx="1410030" cy="4196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71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35496" y="1052736"/>
            <a:ext cx="5328592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939	153239	153259	-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62	82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939:153239-153259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GATATTGGTGCGGTTCAATCAGAAAGCTTGCGCTCTGGAGGCGAGGGGCTCCACTCTTTGATTGAGCCGTGCCAATATC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59	1397272	1397292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102	122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059:1397272-139729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ATGATGTTGGCTCGGCTCACTCAGATCATCGGTGCTGAAGCACGAATCTAAGTACACCGCAGTAATATCAATTAGTGCGATGCTCCTAGCTGGCATTTCTGATTGAGCCGTGCCAATATC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4004" y="44624"/>
            <a:ext cx="1764500" cy="4200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5401986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7504" y="1484784"/>
            <a:ext cx="590465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70	35428	35448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93	113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170:35428-3544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TGTTGGCTCGTCTCACTCAGATCATCTAGTGCTGAATGAAGCATGAATCTAAGTATTACAGTCTTAGTGCAATGCTCCTGCAGGCATTTCTGATTGAGCCGTGCCAATATCT 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390	349074	349094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80	100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390:349074-34909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GATGTTGGCTCGGCTCACTCAGACGACATTGGAGCGATGCATGCATGCGTGATGCTAGCTAGCTCACCGGCGTTTCTGATTGAGCCGTGCCAATATCT 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184" y="471488"/>
            <a:ext cx="1200150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6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6781" y="442913"/>
            <a:ext cx="120967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7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00658991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496" y="1473165"/>
            <a:ext cx="6048672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125	390895	390915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86	106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125:390895-39091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CGATGTTGGCATGGTTCAATCAAATCGGGTGATTTCTGCACTAGCTAGCGCGGTGCAAGGATGTTAATTGTTCTGTTCGATCTGATTGAGCCGTGCCAATATCA 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439	341610	341630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80	100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439:341610-34163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TGTTGGCATGGTTCAATCAAATCGGGTGATACTTCTGCACTAGCTAGCGAGGTGCAAGGATGTTGTTTTGTTCGATCTGATTGAGCCGTGCCAATATCA 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5568" y="442913"/>
            <a:ext cx="1828800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6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36371" y="447675"/>
            <a:ext cx="1000125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7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2255428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7504" y="1187455"/>
            <a:ext cx="6390456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475	187897	187917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63	83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475:187897-187917 ACGGGATATTGCTGCGGTTCAATCAGAAAGCTTGTGCTCCGAAGGCAAGGGGCTCTACTCTTTGATTGAGCCGTGCCAATATCA 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493	108027	108047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84	104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3493:108027-108047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AGATGTTGGCTCGGCTCACTCAGACGACATTGGAGCGACGCACGCATGCACGCATGATGCAAGCTAGCTCACCGGTGTTTCTGATTGAGCCGTGCCAATATCT 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786	44121	44141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60	80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3786:44121-4414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TATTGGTGCGGTTCAATCAGAAAGCTTGCGCTCCGGAGGCGAGGGGCTCCACTCTTTGATTGAGCCGTGCCAATA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184" y="922734"/>
            <a:ext cx="1409700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77050" y="44624"/>
            <a:ext cx="8953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2400" y="337145"/>
            <a:ext cx="92392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7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7552482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14803" y="980728"/>
            <a:ext cx="1469001" cy="54153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7504" y="755987"/>
            <a:ext cx="5772819" cy="4862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4538	30513	30533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60	80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4538:30513-3053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ATATTGGCGCGGTTCAATCAGAAAGCTTGTGCTCCGAAGGCAGGGGCTCGACTCTTTGATTGAGCCGTGCCAATA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4947	54566	54588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AGTCGAGCCAATATCACATC 	59	81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4947:54566-5458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ATGGCATGGTATTGACTTGGCTCAATTCAGCGACCGCGAATTGCACGGTGCCAGAGTTGAGTCGAGCCAATATCACA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255388	283	303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ATTGAGCCGTGCCAATATC 	96	11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255388:283-303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GATGTTGGCTCGTCTCACTCAGATCATCTAGTGCTGAATGAAGCATGAATCTAAGTATTACAGTCTTAGTGCAATGCTCCTGCAGGCATTTCTGATTGAGCCGTGCCAATATCT</a:t>
            </a:r>
          </a:p>
        </p:txBody>
      </p:sp>
      <p:pic>
        <p:nvPicPr>
          <p:cNvPr id="3174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7652" y="968937"/>
            <a:ext cx="1121308" cy="5441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74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849756"/>
            <a:ext cx="982231" cy="5397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7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068521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9512" y="411623"/>
            <a:ext cx="6048672" cy="6709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906	369866	369884	+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	21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906:369866-36988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CCCATGGTGGTTTCTTTGCATCAAGGGACATGCTTGGAGCTATGTGTGCTCACTGCTCTATCTGTCA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039	11164	11182	+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CAGAAGAGAGT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	21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039:11164-1118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CAGAAGAGAGTGAGCACACGACGTGACGGCCGGCATCACAGATATGCCATCCCCGCCGCGTGCTCGCTCTTCTTTCTG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488	mir156c 	110417	110434	+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 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 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 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CAGAAGAGAGTGAGCAC 	2	20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488:110417-11043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GAAGAGAGTGAGCACACATGGTGCCTTTCTTGCATGCTGAATGAGAGAGTTCATGCTTGAAGCTATGTGTGCTCACTTCTCTGTCTGT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8224" y="438150"/>
            <a:ext cx="77152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3725" y="476250"/>
            <a:ext cx="828675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5813" y="452438"/>
            <a:ext cx="82867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5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11385762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496" y="476672"/>
            <a:ext cx="6105650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3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4299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43020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3	17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3	174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130:142999-14302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TTGAGGGAGCTTTCTTCAGCCCACCATGGGAGGTAGCGGGGATTGAATGAGCTGCCGACTCATTCACTCGAACACACGGTGGAATTGATCGATGTACCGTGTGAATGAGTGAATGATGCGGGAGACTCTTCTCTCTTTCCAACTCCATGCTTGGACTGAAGGGTGCTCCCT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28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04213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04230	-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 	233	250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228:304213-30423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TCCTTTCGGTCCAAAAAGGGTGTTGCTGTGGGTGGATTGAGCTGCCGGGTCATGGATCCCGTTAGCCTATTCCATGGTTCCTCACCTGTTTGGCTTGAGATCTGAGTGAGATGACGAGATAGATGTATAGAGATGAGAGAGAAGGTCATATGTGGCTACAGTTCTTGTTGGGATAGGCTTATGGCTTGCATGCCCCAGGAGCTGCATCGGCCCTACATGGACCCTCTTTGGATTGAAGGGAGCT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57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1402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1419	-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 	174	191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257:91402-91419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GAACTCCCTTCGATCCAATCCAGGAGGGGAAGTGGTCGGATGCAGCTGCCGGTTCATGGATACCTCTCTGGTGCATGCGGCGTCGTAGTGAACTAGTAATGTTGTACGCCTGCACTTGCATGGGTGTACATGACCCGGGAGATGAACCCACCAGCATCTTCCTCTCGCGCTTGGATTGAAGGGAGCT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1146" y="260648"/>
            <a:ext cx="84772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8391" y="548630"/>
            <a:ext cx="1400175" cy="582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8566" y="620688"/>
            <a:ext cx="600075" cy="585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1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65552907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19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35496" y="692696"/>
            <a:ext cx="6048671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52	136465	136485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1	17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1	17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252:136465-13648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AGAGCGTCCTTCAGTCCACTCATAGGCGGTGTAGGATCGAATTAGCTGCCGACTCATTCACCCACATGCCTAGCAACGGTCGCGAGCGAGCTTAGCAGATGAGTGAATGAAGCGGGAGGTAAAGTTTTGACCTCGCATCGTCTTTGCTTGGACTGAAGGGTGCTCCCTC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46	1025564	1025585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 	164	18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64	185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046:1025564-102558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TTAAGAGAGAGCTCCCTTCGGTTCACTCGTAAGTGGCAGTGGGGTTTATTTGCTGCCGACTCATTCATTCAAGTACTAAGAACACTGATGCTATGTTTGCAAATCTTAGTAGCTGAGTGAATGGCGCGGGAGCTAATGGTAAGCTCTGCGTTGCTTGTGCTTGGACTGAAGGGTGCTCCCT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82	85681	85701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 	156	176	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182:85681-8570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AGAGAGCTCTCTTCAGTCCACTCTCAGATGGCTGTAGGGTTTTATTAGCTGCCGACTCATCCATTCACCTACCAAGAATCATGGAGGAATGTATGTCTTGGTAGCCGACTGGATGGTGCGGGAGCTAAAATCTAGCTCTGCGTTGTTTGTGGTTGGACTGAAGGGTGCTCCCT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9395" y="461963"/>
            <a:ext cx="54292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24328" y="457200"/>
            <a:ext cx="10287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37004" y="466725"/>
            <a:ext cx="571500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27578229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19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35496" y="836712"/>
            <a:ext cx="6912768" cy="4678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57	162218	162239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3	17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3	174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257:162218-162239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GAGAGCGTCCTTCGGTCCACTCACAGGCGGTGCTAAGGTCGAATTAGCTGCCGACTCATTCACCCACATGCCAAGCAACGGTAGTGAGAGAGCTTAGCAGATGAGTGAATGAAGCGGGAGGTAAAGTTTTGATCTCGCACCATCTTTGCTTGGACTGAAGGGTGCTCCCTC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68	358151	358171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CTGAAGGGTGCTCCCT 	157	177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568:358151-35817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TAGAGAGCTCTCTTCAGTCCACTCTCAGATGGCTGTAGGGTTTTATTAGCTGCCGACTCATCCATTCACCTACCAAGAATCATGGAGGAGTGTATGTCGTGGTAGCCGACTGGATGGCGCGGGAGCTAAAATTTATCTCTGCGCCGTTTGTGGTTGGACTGAAGGGTGCTCCCT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689	77184	77201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 	237	254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689:77184-7720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TGGAGCTCCTTTCGGTCCATAAAGGGTGTTGCTGTGGGTGGATTGAGCTGCTGGGTCATGGACCCCGTTAGCCTATTCCATGGTTCCTCACCTGCTGTTTGGCTTGAGATACTAGAGAGATGAAGAATTAGATGTGTAGAGATGAGAGAGAGAGGTGTTCGGCTGCATTTCTTGTTGGGATAGGCTTATGGCTTGCATGCCCCAGGAGCTGCATCAGCCCTACATGGACCCTCTTTGGATTGAAGGGAGCTC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6256" y="461963"/>
            <a:ext cx="69532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75587" y="1027509"/>
            <a:ext cx="1304925" cy="585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38975" y="-27384"/>
            <a:ext cx="733425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70356161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3" y="1052736"/>
            <a:ext cx="6480720" cy="5293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697	189691	189708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 	200	217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697:189691-18970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CTCCTTTCGTTCCAATGAATGGTCTGTTTGAAGGGTGGTACAGCTGCTTGTTCATGGTTCCCACTATCCTATCTCATTAGAAAGAGTACTGAGATAGACAGAGATCGAGAGGTATGAAACAGATATGGGCGTATTGAGATAGGCTTGTGGTTTGCATGACCCAGGAGCTGCATCAACCCCTTGCCGACCGCTGTTTGGATTGAAGGGAGCTC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52	163903	163920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 	180	197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252:163903-16392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GAAGAGCTCCCTTCGATCCAATCCAGGAGGGGAAGTGGTCGGATGCAGCTGCCGGTTCATGGATACCTCTGTGGTGCACGCAGCGTGGTGGTAGCTAGTCATATACGCTGTACGCCTGCACTTGCACGGGTGTGCATGACCCGGGAGATGAACCCACCAGCATCTTCCTCTCGTGCTTGGATTGAAGGGAGCTC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017	36363	36380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 	192	209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3017:36363-3638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TCCTTTCATTCCAATGAATGGTCTATTTGAAGGGTGGTACAGCTGCTTGTTCATGGTTCCCACTATCCTATCTCATTAGAAAGAGATCAGTGAGAGAGAGATCGATATATATGGACTATATGTTGACTTGAGATAGGCTTGTGGTTTGCATGACCCAGGAGCTGCATCAACCCCTTGCCGACCGCTGTTTGGATTGAAGGGAGCTC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8224" y="998934"/>
            <a:ext cx="1114425" cy="5886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2320" y="15205"/>
            <a:ext cx="80010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42287" y="960834"/>
            <a:ext cx="1038225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1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0350688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7543" y="188640"/>
            <a:ext cx="1266825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8104" y="0"/>
            <a:ext cx="126682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23212" y="212179"/>
            <a:ext cx="1257300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5496" y="579452"/>
            <a:ext cx="5256584" cy="455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PH01000026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3506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235085	-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CCACAGCTTTCTTGAACTG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026:1235065-123508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CCACAGCTTTCTTGAACTGCATGACTCTGAAGTGGCGGCAGCACCCTCCCCGATCTGCTTAATCTGGGAGGAGATCGTAGATCGCTTGGCTTGCATGAGAGAGCAGTTCAATAAAGTTGTGGGA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36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86512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86532	-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CCACAGCTTTCTTGAACTG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036:286512-28653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CCACAGCTTTCTTGAACTGCATGAATCTGAAGTGGCGGCAGCACCCTCCCTGATCTTCTTTGGGAGGAGATCGTAGATCGCTTGGTGCTTGCATGAGAGAGCAGTTCAATAAAGCTGTGGGAAA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4375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7678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7698	-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CCACAGGCTTTCTTGAACTG 	2	22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4375:77678-77698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CCACAGGCTTTCTTGAACTGTGAACTCGTGGGGTGGGGGTTTGTAGAATCAAGAATATGGTGGATGGCTTCGTGTGAGTTCAATTATCTCTGAATTGTGGAGCTCTCGGTTTCTCTCTTGTCATCTCTACCTGTTGATGGTTCAAGAAAGCCCATGGAAA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9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0171660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476250"/>
            <a:ext cx="1162050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7503" y="908720"/>
            <a:ext cx="6053633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4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17864	117884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CACAGGCTTTCTTGAA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140:117864-11788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CACAGGCTTTCTTGAACTGTGAACTCGTGCTCAATTCTTTTGCCTTCGATCTCTTCCCCTCTGGGGCGATTGAGTTTAATTTTCGCCTTGTTGATAGTTCAAGAAAGTCCTTGGAA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PH01000828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7153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7173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CCACAGCTTTCTTGAACTG 	1	21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828:157153- 15717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CCACAGCTTTCTTGAACTGCATCTGCAATGGATATTAGTACTTTTCTGGCTTCTACTTGCAATAGTGCAGTTCAATAAAGTTGTGGGAAA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40	25286	25306	+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CCACAGCTTTCTTGAACTG 	1	21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240:25286-2530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CCACAGCTTTCTTGAACTGCATCTGTAATGGACAGCAGTACTCTTCTGGCTTCTACTTGCAAGAGTGCAGTTCAATAAAGCTGTGGGAA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686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31124" y="481013"/>
            <a:ext cx="1257300" cy="5895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96</a:t>
            </a:r>
            <a:endParaRPr lang="en-GB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08404" y="461963"/>
            <a:ext cx="80010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91689623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3529" y="836712"/>
            <a:ext cx="6336704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93	911179	911200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TGAGTGCAGCGTTGA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93:911179-91120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GAACCGGCCGGCGAGCGGCCGTGCATCCACGGTCAATCTTCGCTCACCAGCGCTGCACTCAATC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27	409794	409815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TTGAGTGCAGCGTTGA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2	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27:409794-409815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TTGAGTGCAGCGTTGATGAACCGGCCATCTAATATGATCCATCCCTGCATCTTGTTGCCTTCCATGAGATCTGAAATAGGAGCGGTTCACCAGCGCCGCACCCAATA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0232" y="466725"/>
            <a:ext cx="1343025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94079" y="-27384"/>
            <a:ext cx="1114425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9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14193816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0346" y="438150"/>
            <a:ext cx="34861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95537" y="1899989"/>
            <a:ext cx="597666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50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250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02529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GTTCTCAGGTCACCCCT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7	97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509:102509-102529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GGAGTGCCACTGAGAACACAGATGCAGCTGCAAATGCAAATGTATGGCAAACTACTGCAAATTGGATCGCAGTTGTGTTCTCAGGTCACCCCT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9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8126207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51520" y="2274838"/>
            <a:ext cx="691276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36	344087	344107	+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CAGTTCACCTTTGGCACC 	1	21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TGCCGAAGGAGAACTGCC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9	99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0536:344087-344107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CAGTTCACCTTTGGCACCAAGGTCAGCCATGCATAGCAGAGGAGCGGCAGCCGATGGTGTTAATTAGCAACCTAGTGCCGAAGGAGAACTGCCCTGCGATT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99</a:t>
            </a:r>
            <a:endParaRPr lang="en-GB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60096" y="500063"/>
            <a:ext cx="1676400" cy="585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54019865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0793752">
            <a:off x="6437472" y="452438"/>
            <a:ext cx="280987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6096" y="452438"/>
            <a:ext cx="191452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2" y="620688"/>
            <a:ext cx="6120680" cy="5324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907	95874	95893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GGATGAGGCAGAGCA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GGATGAGGCAGAGCAT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CACTGCCTCTTCCCTG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1	17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CTGCCTCTTCCCTG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2	17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CTGCCTCTTCCCTGG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52	17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907:95874-95893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GATGAGGCAGAGCATGGGATGGGGCTATCAACAAATTTCTTTCTTCCCTACATGTTCGTTTCTATATTTCCTCTATGGCAAGCACAAAGCAAATCGTTGGGCAGGAGAGAGCTGCGAGAGATGAGCTGGTGTTGTTGCTCCCTCCCCTGCACTGCCTCTTCCCTGGCT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04	464988	465008	+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GGACGAGGCAGAGCA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	1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GGACGAGGCAGAGCA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CAGGGACGAGGCAGAGCAT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CTGCCTCTTCCCTG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47	16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CTGCCTCTTCCCTGG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47	167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04:464988-465008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AGGGACGAGGCAGAGCATGGGATGGGGCTATCAACAAATTTCTTTCTTCCACTACATATTTGTTTCTGTGGCAGACGCAAAGCAAACTGTTAGGCAGGAGAGAGTTTTGATGAGAGAGATGAGCTGGTGTTGTTGTTCCCTCCCGTGCACTGCCTCTTCCCTGGCTCCCCTGCA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40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655529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36296" y="457200"/>
            <a:ext cx="187642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35496" y="332656"/>
            <a:ext cx="6048672" cy="65556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28	304215	304231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6	25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6	25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6	255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7	255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6	25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T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7	256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28:304215-304231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GGAGCTCCTTTCGGTCCAAAAAGGGTGTTGCTGTGGGTGGATTGAGCTGCCGGGTCATGGATCCCGTTAGCCTATTCCATGGTTCCTCACCTGTTTGGCTTGAGATCTGAGTGAGATGACGAGATAGATGTATAGAGATGAGAGAGAAGGTCATATGTGGCTACAGTTCTTGTTGGGATAGGCTTATGGCTTGCATGCCCCAGGAGCTGCATCGGCCCTACATGGACCCTCTTTGGATTGAAGGGAGCTCTG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57	91401	91420	-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7	19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8	19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GGATTGAAGGGAGCT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7	197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TGGATTGAAGGGAGCT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8	197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57:91401-9142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AGAAGAACTCCCTTCGATCCAATCCAGGAGGGGAAGTGGTCGGATGCAGCTGCCGGTTCATGGATACCTCTCTGGTGCATGCGGCGTCGTAGTGAACTAGTAATGTTGTACGCCTGCACTTGCATGGGTGTACATGACCCGGGAGATGAACCCACCAGCATCTTCCTCTCGCGCTTGGATTGAAGGGAGCTCT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689	77184	77203	+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7	25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7	255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7	25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8	256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689:77184-7720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GGAGCTCCTTTCGGTCCATAAAGGGTGTTGCTGTGGGTGGATTGAGCTGCTGGGTCATGGACCCCGTTAGCCTATTCCATGGTTCCTCACCTGCTGTTTGGCTTGAGATACTAGAGAGATGAAGAATTAGATGTGTAGAGATGAGAGAGAGAGGTGTTCGGCTGCATTTCTTGTTGGGATAGGCTTATGGCTTGCATGCCCCAGGAGCTGCATCAGCCCTACATGGACCCTCTTTGGATTGAAGGGAGCTC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59</a:t>
            </a:r>
            <a:endParaRPr lang="en-GB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168" y="188640"/>
            <a:ext cx="1304925" cy="585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1159" y="188640"/>
            <a:ext cx="657225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5552907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0454" y="1268760"/>
            <a:ext cx="1898049" cy="51082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2120" y="-99392"/>
            <a:ext cx="2447869" cy="5333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5496" y="1484784"/>
            <a:ext cx="6768752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146	927818	927838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GTTGTTGTCTCAAGCT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3	193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146:927818-92783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TTGGAGGGCACTTATTCTTGCTTATTGTCTCTATTACTTGCAACAGTGTAGCTGAATTCAGATAGTACATACTTGTACTTCTCTTTCTGAACAAACAAGCTTCTAATGAAAAATATGTTTGTAACTTTTGCAGGGTTTTCAGACCATACCGATGATTTTCTTGCAGGTTGTGCAGTTGTTGTCTCAAGCTTG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075	195034	195054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GTTGTTGTCTCAAGCT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TGTCTCAAGCTTGCTG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7	27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075:195034-195054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GTTGTTGTCTCAAGCTTGCTGCCTCCCGTTGCCAGAACTATTGAATATAAAAGGCACGGTTAAGTAACGCTAAATCCAGGTTTGCCAAAAGCATTGAAACAAACATGTTGC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44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2757822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088" y="136331"/>
            <a:ext cx="1982713" cy="4948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7505" y="601518"/>
            <a:ext cx="5688631" cy="4862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01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6977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469794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TTGTCTCAAGCTTGCTGC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501:469774-46979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TTGTCTCAAGCTTGCTGCCTCGCTTTGCCAAAACTATCAAGTGTAAAAAGCAGAGTTATGCTTTTCTATAAAAAGAACAGAGTTATGCAACTTAAAGACACATTAGGCAAAAGTAAAGTAATAAACATGTCTCAGCAAC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6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8070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80724	-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AGTTGTTGCCTCAAGCT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80	300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569:380704-38072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CATGGGTTGAGGCAGAACAACTTATTATGTTGTTGGAAGAGAGTCACAATTAATTTCCTTTTCGTAACAGCTATTACTCTAAATTTTTTCAGTAACTAACTTTTTCCTCATCCTGGCTGAATGAAGTATTTCATTTTTGTATTGACTGTTCTTATAAAGTTTACCATGTGGTATTCAAATTATGTATAAGCTACTTTTATGAGGAATTATTAATGGGTGATCTATTTTCTTTGCAGAATCGATAGAAGATCATACTTGTGACTTTCTTGCAAGTTGTGCAGTTGTTGCCTCAAGCT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TGTTGTCTCAAGCTTGCTGCC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CTTGAGGCAACAACTGCA [rev comp]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97321">
            <a:off x="7383327" y="609047"/>
            <a:ext cx="1620199" cy="51416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44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2899780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692696"/>
            <a:ext cx="5904656" cy="6093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59	1176548	1176566	+	</a:t>
            </a: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 	1	19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059:1176548-117656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GATCCTGGCACAGGAGGTTTGATCTGAAGCCAACCAACTTTCATTGCCTCCTCTGCTTGCCTCTCCCACT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36	348334	348353	+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A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GGGCATGCAGAGGA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236:348334-34835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AGCAAGAGATTTGGTCGGAAGCCGGCCTATGCCTCCCTCTCTCTCCTGTGCTTGCCTCTTCCA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370	738924	738943	+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AG 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GGGCATGCAGAGGA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0370:738924-738943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AGGGGCATGCAGAGGAGCAGGAGATTTTGGTTGGAAGCCGGCCTGTGCTTCCCTCTCTCTCCTGTGCTTGCCTCTTCCA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2" y="457200"/>
            <a:ext cx="109537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8257" y="1979579"/>
            <a:ext cx="1012135" cy="4430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61890" y="44624"/>
            <a:ext cx="1146614" cy="44024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52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14193816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201" y="491530"/>
            <a:ext cx="5904656" cy="64017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21	1143649	1143665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8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 	2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021:1143649-114366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CAACGAGAGAGAGCACGCCGGTGCGGCGGTCACGGCCGGAGCCGCCCGCGGCCGTGTACTCGCGTGCTCCTTCCCGTTGTCACTTCC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65	184404	184420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47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4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4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5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5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5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31	15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265:184404-18442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GATTTTGTTCTTCTTGTTGCTCTCCTTCTTTTCTCTAATCGGTTTCGGTTTGGTTCTGTCGGTGCAGGAGACGTGTAGATTTCTTGTACGATGCCGGGCCGGAGTTGAGTAAGATTTGGTTCTGGCGGTGACAACGAGAGAGAGCACGC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65	381222	381238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1265:381222-381238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CAACGAGAGAGAGCACGCCGGTGCGACGGTCACGGCGAGCGGCCCGCGGCGGCGTACTTGCGTGCTTCCTCCCGTTGTCAC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535</a:t>
            </a:r>
            <a:endParaRPr lang="en-GB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5857" y="116632"/>
            <a:ext cx="1285875" cy="5905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86017" y="92819"/>
            <a:ext cx="71437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4305" y="-7099"/>
            <a:ext cx="63817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54019865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496" y="548680"/>
            <a:ext cx="5832648" cy="64017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345	63430	63446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0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1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1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1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1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1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93	113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2345:63430-6344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TTCTTGCTGTTGTCGTTGCTCTCAACTAATCTTTGCCTACATGATTTCAGGTCAAGTGCTGGAGATTGATTTGTGTGAGGTGGTGGTGGTGACAACGAGAGAGAGCACGC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4182	79781	79797	-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4182:79781-79797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CAACGAGAGAGAGCACGCTGGTGCGGCGGTCACGGCGAGGTGGCCCGCGGCGGCGTACTTGCGTGCCCCCTCCCGTTGTCACTG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768	289104	289124	+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7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8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1768:289104-289124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CAACGAGAGAGAGCACGCCGGTGCGGCGGTCACGGCGAGGTGGCCCGCGGCGGCGTACTTGCGTGCTCCCTCCCGTTGTCACT</a:t>
            </a: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535</a:t>
            </a:r>
            <a:endParaRPr lang="en-GB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8104" y="116632"/>
            <a:ext cx="1400175" cy="584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2295" y="244015"/>
            <a:ext cx="809625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9138" y="332656"/>
            <a:ext cx="895350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71348511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7235" y="1246107"/>
            <a:ext cx="6696744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780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20442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420462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AGATGACCATCAGCAAACA 	67	87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780:420442-42046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TTTTGTTGGTTGTCATCTAACCATCGATCCATGCTTTGGTTGTGTGTTGTGTGATGGTGGTGGTTAGATGACCATCAGCAAACA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PH01001462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5259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85279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TTAGATGACCATCAGCAAACA 	85	105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1462:85259-85279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TTTTGCTGGTCGTCATCTAGCCATGCTTTGTTTGGTGCGTGGAGTGTGGCAGCAGTGTGCTGATCATGCACATACGCATGGTTAGATGACCATCAGCAAACAT 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5751" y="442913"/>
            <a:ext cx="1190625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6376" y="457200"/>
            <a:ext cx="11811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82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71348511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4" y="-1746"/>
            <a:ext cx="1350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432</a:t>
            </a:r>
            <a:endParaRPr lang="en-GB" dirty="0"/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184" y="438150"/>
            <a:ext cx="10096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9513" y="692696"/>
            <a:ext cx="5976664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PH01000086	</a:t>
            </a:r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44965</a:t>
            </a:r>
            <a:r>
              <a:rPr lang="de-DE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644985	</a:t>
            </a:r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</a:t>
            </a:r>
          </a:p>
          <a:p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GAGAGATGACACCGACA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</a:t>
            </a:r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86:644965-644985</a:t>
            </a:r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CAGGAGAGATGACACCGACATCAAATGGATTGGTTTGTACTATGTCCATCCGTTTGAAGTTGGTGTCATCTCGCCTGA</a:t>
            </a: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PH01008094	</a:t>
            </a:r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5304</a:t>
            </a:r>
            <a:r>
              <a:rPr lang="de-DE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15324	</a:t>
            </a:r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+</a:t>
            </a:r>
          </a:p>
          <a:p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GGAGAGATGACACCGACA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GB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1</a:t>
            </a:r>
            <a:endParaRPr lang="de-DE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2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8094:15304-15324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CAGGAGAGATGACACCGACATCAAATGGATTGATTTGGACTATGTCCACCCGTTTGAAGTGGGTGTCATCTCGCCTGA</a:t>
            </a:r>
          </a:p>
          <a:p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31707" y="447675"/>
            <a:ext cx="1228725" cy="596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50335799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1521366"/>
            <a:ext cx="583264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PH01000596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31688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31708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CCTTCGGGGGAGGAGGGAAGC 	83	103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PH01000596:231688-231708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CTTTCTTGGATCCCTCTCTCCCTTGAAGGCTCTCTCTTGGAGTTGGAGGCTTCATGTCCACCATTCTTGCCTAAGAAAGCCTTCGGGGGAGGAGGGAAGCC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8224" y="452438"/>
            <a:ext cx="2476500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350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397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70429596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2704295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70837" y="461963"/>
            <a:ext cx="120967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2" y="493504"/>
            <a:ext cx="5976664" cy="6247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697	189691	189710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8	214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8	216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8	217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9	217	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697:189691-189710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GCTCCTTTCGTTCCAATGAATGGTCTGTTTGAAGGGTGGTACAGCTGCTTGTTCATGGTTCCCACTATCCTATCTCATTAGAAAGAGTACTGAGATAGACAGAGATCGAGAGGTATGAAACAGATATGGGCGTATTGAGATAGGCTTGTGGTTTGCATGACCCAGGAGCTGCATCAACCCCTTGCCGACCGCTGTTTGGATTGAAGGGAGCTCT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52	163903	163922	+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(*)AGCTCCCTTCGATCCAA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19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2	191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73	191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252:163903-163922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CTCCCTTCGATCCAATCCAGGAGGGGAAGTGGTCGGATGCAGCTGCCGGTTCATGGATACCTCTGTGGTGCACGCAGCGTGGTGGTAGCTAGTCATATACGCTGTACGCCTGCACTTGCACGGGTGTGCATGACCCGGGAGATGAACCCACCAGCATCTTCCTCTCGTGCTTGGATTGAAGGGAGCTCT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017	36363	36382	+	</a:t>
            </a:r>
          </a:p>
          <a:p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4	210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4	21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4	213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GATTGAAGGGAGCTCT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95	213	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017:36363-36382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AGCTCCTTTCATTCCAATGAATGGTCTATTTGAAGGGTGGTACAGCTGCTTGTTCATGGTTCCCACTATCCTATCTCATTAGAAAGAGATCAGTGAGAGAGAGATCGATATATATGGACTATATGTTGACTTGAGATAGGCTTGTGGTTTGCATGACCCAGGAGCTGCATCAACCCCTTGCCGACCGCTGTTTGGATTGAAGGGAGCTCT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176" y="466725"/>
            <a:ext cx="1390650" cy="592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27565" y="461963"/>
            <a:ext cx="695325" cy="593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5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275782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3" y="692696"/>
            <a:ext cx="6048671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26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0353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503554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264:503534-50355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CCTGGCTCCCTGTATGCCACTCATCTAGAGCAACAACTTTCCAAGGTTGCCTAGGATGGCTGGCGTGCACGGAGCCAAGCATA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483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47644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447664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483:447644-447664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CCTGGCTCCCTGTATGCCACACATGTAGCCCAATCCATGGTGTGATTGGATGCTGTGGGTGGCGTGCAAGGAGCCAAGCATGC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1046 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35323	335343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1046:335323-335343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CCTGGCTCCCTGTATGCCACTCATCTAGAACAACGACTTTCTAAGGTTGCCTACGATGGCTGGCGTGCACGGAGCCAAGCAT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0363" y="116632"/>
            <a:ext cx="923925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80659" y="116632"/>
            <a:ext cx="84772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0955" y="452438"/>
            <a:ext cx="771525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190572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2" y="1028343"/>
            <a:ext cx="6336704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2185	168312	168332	-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	2	22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2185:168312-168332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CCTGGCTCCCTGTATGCCACACATGTAGCCCAATCCATGGTGTGATTGGATGCTGTGGGTGGCGTGCAAGGAGCCAAGCAT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422	7769	7789	-	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	2	22	</a:t>
            </a: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3422:7769-7789</a:t>
            </a:r>
            <a:endParaRPr lang="en-GB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CCTGGCTCCCTGTATGCCACTCGCATAGCTGCCAACTCAGCTGATCTCCGATCGAGGGCACGTACGTTGGCTCTACTGCGGATGGCGTGCGAGGAGCCAAGCAT</a:t>
            </a:r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2280" y="260648"/>
            <a:ext cx="63817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6376" y="264096"/>
            <a:ext cx="63817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60839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5" y="1086410"/>
            <a:ext cx="6120680" cy="4862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093 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289935	289955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093:289935-28995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CACATGTAGCCCAATCCATGATGTGGTTGCCTGCTGTGGGTGGCGTGCAAGGAGCCAAGCATGCAT</a:t>
            </a: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331 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84075	384095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</a:t>
            </a:r>
            <a:r>
              <a:rPr lang="en-GB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1	2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 PH01000331:384075-384095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CTCGCATGGCTGCCAACCGGAGCTCATCGTTGGCCGCTGCGGCTGGCGTGCGAGGGGCCAAGCA</a:t>
            </a:r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H01000500 </a:t>
            </a:r>
            <a:r>
              <a:rPr lang="de-DE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	301026	301046	+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 	1	21	</a:t>
            </a:r>
            <a:endParaRPr lang="de-DE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PH01000500:301026-301046</a:t>
            </a:r>
          </a:p>
          <a:p>
            <a:r>
              <a:rPr lang="de-DE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CCTGGCTCCCTGTATGCCACTCGCATTGCTGCCAACCGGAGATTCATCGTTGGCCGCTGCGGCTGGCGTGCGAGGGGCCAAGCA</a:t>
            </a:r>
          </a:p>
          <a:p>
            <a:endParaRPr lang="de-DE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1010392">
            <a:off x="6251311" y="548680"/>
            <a:ext cx="17145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7741" y="438150"/>
            <a:ext cx="828675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1254" y="438150"/>
            <a:ext cx="8572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64" y="-1746"/>
            <a:ext cx="12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iRNA</a:t>
            </a:r>
            <a:r>
              <a:rPr lang="en-GB" dirty="0" smtClean="0"/>
              <a:t> 16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83388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88</TotalTime>
  <Words>171</Words>
  <Application>Microsoft Office PowerPoint</Application>
  <PresentationFormat>On-screen Show (4:3)</PresentationFormat>
  <Paragraphs>1499</Paragraphs>
  <Slides>5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8</vt:i4>
      </vt:variant>
    </vt:vector>
  </HeadingPairs>
  <TitlesOfParts>
    <vt:vector size="5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ast Angl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na Mohorianu</dc:creator>
  <cp:lastModifiedBy>Ping Xu (BIO)</cp:lastModifiedBy>
  <cp:revision>63</cp:revision>
  <dcterms:created xsi:type="dcterms:W3CDTF">2014-03-23T17:52:56Z</dcterms:created>
  <dcterms:modified xsi:type="dcterms:W3CDTF">2014-04-23T13:22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664173540</vt:i4>
  </property>
  <property fmtid="{D5CDD505-2E9C-101B-9397-08002B2CF9AE}" pid="3" name="_NewReviewCycle">
    <vt:lpwstr/>
  </property>
  <property fmtid="{D5CDD505-2E9C-101B-9397-08002B2CF9AE}" pid="4" name="_EmailSubject">
    <vt:lpwstr>manuscript update</vt:lpwstr>
  </property>
  <property fmtid="{D5CDD505-2E9C-101B-9397-08002B2CF9AE}" pid="5" name="_AuthorEmail">
    <vt:lpwstr>P.Xu3@uea.ac.uk</vt:lpwstr>
  </property>
  <property fmtid="{D5CDD505-2E9C-101B-9397-08002B2CF9AE}" pid="6" name="_AuthorEmailDisplayName">
    <vt:lpwstr>Ping Xu (BIO)</vt:lpwstr>
  </property>
</Properties>
</file>